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199313" cy="1026001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60665C-8435-41CB-BAF0-F58592DBA12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60360" y="2394000"/>
            <a:ext cx="64800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60360" y="5931720"/>
            <a:ext cx="64800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C11A5A-28D0-4CDB-B145-276A800768B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60360" y="239400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680640" y="239400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60360" y="593172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680640" y="593172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15C88F-A568-467B-8C96-FAB3E471C42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60360" y="2394000"/>
            <a:ext cx="20862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551320" y="2394000"/>
            <a:ext cx="20862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742280" y="2394000"/>
            <a:ext cx="20862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60360" y="5931720"/>
            <a:ext cx="20862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551320" y="5931720"/>
            <a:ext cx="20862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742280" y="5931720"/>
            <a:ext cx="20862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48D156-50DF-4DC0-BA56-81216221FFD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60360" y="2394000"/>
            <a:ext cx="6480000" cy="6772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08735A-5C7E-469C-87AB-6355E54E97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60360" y="2394000"/>
            <a:ext cx="6480000" cy="677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9FC595-60C8-48B7-8866-95DA1C1E074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60360" y="2394000"/>
            <a:ext cx="3161880" cy="677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680640" y="2394000"/>
            <a:ext cx="3161880" cy="677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20A0AD-991D-45E9-BCF1-C4A8122FE6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D1F1EE-904C-4927-ABAB-1E0116977F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60360" y="410760"/>
            <a:ext cx="6480000" cy="7926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7ABE70-6B1B-45D5-BFFC-095E272479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60360" y="239400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680640" y="2394000"/>
            <a:ext cx="3161880" cy="677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60360" y="593172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6AA609-D690-4FE1-AE6C-7D395DF020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60360" y="2394000"/>
            <a:ext cx="3161880" cy="677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680640" y="239400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680640" y="593172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677C4E-0F17-4873-9D33-0D69FCB0F0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60360" y="239400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680640" y="239400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60360" y="5931720"/>
            <a:ext cx="64800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F1B908-4772-474E-BE98-0A3A6347A6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60360" y="2394000"/>
            <a:ext cx="6480000" cy="677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60000" y="9344160"/>
            <a:ext cx="1679400" cy="712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460600" y="9344160"/>
            <a:ext cx="2279520" cy="712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160600" y="9344160"/>
            <a:ext cx="1679400" cy="712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4A38359-2A52-4C8B-9755-2BC22E3F60B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0" t="2961" r="0" b="2742"/>
          <a:stretch/>
        </p:blipFill>
        <p:spPr>
          <a:xfrm>
            <a:off x="781200" y="482760"/>
            <a:ext cx="5618160" cy="754380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324000" y="8177760"/>
            <a:ext cx="6634080" cy="162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resentation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3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︱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2-DE comparison of embryo protein profiles between maize mutant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vp5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and wild type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Vp5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.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A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,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B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and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C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represent three biological replicates. About 600 μg proteins were loaded into 11-cm linear pH 7-10 IPG strips for IEF. Secondary SDS-PAGE was run in 13.5% gels. Approximately 130±5 CBB-stained spots were detected in gel, reproducibly. Those differentially expressed embryo protein spots display a consistent change in the three biological replicates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雨林木风</cp:lastModifiedBy>
  <dcterms:modified xsi:type="dcterms:W3CDTF">2014-10-20T02:58:19Z</dcterms:modified>
  <cp:revision>29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3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TitleName">
    <vt:lpwstr>Presentation 3.PPT</vt:lpwstr>
  </property>
  <property fmtid="{D5CDD505-2E9C-101B-9397-08002B2CF9AE}" pid="6" name="Version">
    <vt:r8>1</vt:r8>
  </property>
</Properties>
</file>